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0BF844-509D-4E9F-A618-F272A32428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8420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42680" y="4130640"/>
            <a:ext cx="8420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186A4-9A1B-4BB7-9116-ACF560F411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426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572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447D7-AD8F-4522-83DA-ACCD385AD7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89920" y="198108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36800" y="198108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42680" y="413064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89920" y="413064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36800" y="4130640"/>
            <a:ext cx="27111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1E83C-FFED-4704-A744-07A02B2A86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42680" y="1981080"/>
            <a:ext cx="842004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1BFB2-59A6-47F9-8A0C-ADA1E8D11E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8420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FE1F0-8885-4B83-90CA-8FA7D567D3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B46AC-F787-4964-9E65-01DC2A37DD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2E6A3-AECC-4ABA-A1F8-463FBB650C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42680" y="609120"/>
            <a:ext cx="842004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DCB85-EF54-41EC-8FBF-CE205A921B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426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70376C-3E43-4C53-BBB7-4815542DCC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57280" y="413064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C4F2E8-2BC9-4CFA-8BF2-13D495E474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426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57280" y="1981080"/>
            <a:ext cx="41086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42680" y="4130640"/>
            <a:ext cx="8420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5F445-B3BE-43FE-A44E-3EBC6D03F8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42680" y="609120"/>
            <a:ext cx="8420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42680" y="1981080"/>
            <a:ext cx="8420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ffff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ffffff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ffffff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43040" y="6248520"/>
            <a:ext cx="20635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8520"/>
            <a:ext cx="31366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8520"/>
            <a:ext cx="20638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C8805E-B425-4482-A355-6963A99B8A9A}" type="slidenum">
              <a:rPr b="0" lang="en-GB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943280" y="1434960"/>
            <a:ext cx="604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) Haemocyte Resistant-Susceptible (Resistant specific library)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208240" y="1857240"/>
            <a:ext cx="2340000" cy="155916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3179880" y="1951200"/>
            <a:ext cx="123840" cy="1173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720" bIns="367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511440" y="2590920"/>
            <a:ext cx="123840" cy="1188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2921040" y="2203560"/>
            <a:ext cx="123840" cy="1188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916440" y="2344680"/>
            <a:ext cx="120600" cy="1191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800" bIns="37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4073400" y="2019240"/>
            <a:ext cx="123840" cy="1206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520" bIns="385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4175280" y="2265480"/>
            <a:ext cx="120600" cy="1206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520" bIns="385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152960" y="2416320"/>
            <a:ext cx="154080" cy="1508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2836800" y="2103480"/>
            <a:ext cx="154080" cy="1508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149640" y="2554200"/>
            <a:ext cx="198360" cy="16200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2317680" y="2262240"/>
            <a:ext cx="200160" cy="168120"/>
          </a:xfrm>
          <a:prstGeom prst="diamond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53" name="" descr=""/>
          <p:cNvPicPr/>
          <p:nvPr/>
        </p:nvPicPr>
        <p:blipFill>
          <a:blip r:embed="rId2"/>
          <a:stretch/>
        </p:blipFill>
        <p:spPr>
          <a:xfrm>
            <a:off x="4564080" y="1857240"/>
            <a:ext cx="2274840" cy="15559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5462640" y="1974960"/>
            <a:ext cx="119160" cy="1206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520" bIns="385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5784840" y="2608200"/>
            <a:ext cx="119160" cy="1191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800" bIns="37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5210280" y="2220840"/>
            <a:ext cx="117360" cy="1206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520" bIns="385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6176880" y="2362320"/>
            <a:ext cx="120600" cy="1188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6365880" y="2038320"/>
            <a:ext cx="119160" cy="1191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800" bIns="37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6423120" y="2270160"/>
            <a:ext cx="117360" cy="1191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800" bIns="37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5126040" y="2124000"/>
            <a:ext cx="149400" cy="1494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6388200" y="2409840"/>
            <a:ext cx="150840" cy="1490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621320" y="2273400"/>
            <a:ext cx="199800" cy="172800"/>
          </a:xfrm>
          <a:prstGeom prst="diamond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0" bIns="396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7056360" y="2247840"/>
            <a:ext cx="180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uster 4 (FREP-like)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7056360" y="2008080"/>
            <a:ext cx="141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uster 5 (Ferritin)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7057800" y="248616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uster 3 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7057800" y="272412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uster 2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7058160" y="2962440"/>
            <a:ext cx="68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ZB9413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68" name="" descr=""/>
          <p:cNvPicPr/>
          <p:nvPr/>
        </p:nvPicPr>
        <p:blipFill>
          <a:blip r:embed="rId3">
            <a:lum bright="24000"/>
          </a:blip>
          <a:stretch/>
        </p:blipFill>
        <p:spPr>
          <a:xfrm>
            <a:off x="2208240" y="3830760"/>
            <a:ext cx="2239920" cy="157140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3638520" y="4075200"/>
            <a:ext cx="117360" cy="1220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960" bIns="39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2749680" y="5127480"/>
            <a:ext cx="115920" cy="1209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2597040" y="4645080"/>
            <a:ext cx="117720" cy="1191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800" bIns="37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3483000" y="4729320"/>
            <a:ext cx="117360" cy="1206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520" bIns="385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3801960" y="4408560"/>
            <a:ext cx="117720" cy="1220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960" bIns="39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111560" y="4240080"/>
            <a:ext cx="117720" cy="1191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800" bIns="37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2897280" y="4940280"/>
            <a:ext cx="137880" cy="1443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157640" y="4441680"/>
            <a:ext cx="184320" cy="14148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77" name="" descr=""/>
          <p:cNvPicPr/>
          <p:nvPr/>
        </p:nvPicPr>
        <p:blipFill>
          <a:blip r:embed="rId4"/>
          <a:stretch/>
        </p:blipFill>
        <p:spPr>
          <a:xfrm>
            <a:off x="4564080" y="3830760"/>
            <a:ext cx="2319480" cy="161136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>
            <a:off x="6026040" y="4141800"/>
            <a:ext cx="119160" cy="12708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560" bIns="435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5103720" y="5211720"/>
            <a:ext cx="122400" cy="1238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1040" bIns="410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946760" y="4726080"/>
            <a:ext cx="122040" cy="1238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1040" bIns="410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5862600" y="4813200"/>
            <a:ext cx="120600" cy="1238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1040" bIns="410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6194520" y="4486320"/>
            <a:ext cx="120600" cy="12528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1760" bIns="417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6515280" y="4311720"/>
            <a:ext cx="122040" cy="1238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1040" bIns="410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5257800" y="5048280"/>
            <a:ext cx="142920" cy="1476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6570720" y="4459320"/>
            <a:ext cx="195120" cy="13824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7062480" y="4064040"/>
            <a:ext cx="73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uster 1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7062840" y="4265640"/>
            <a:ext cx="71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ZB9365 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6981840" y="4338720"/>
            <a:ext cx="135000" cy="1364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7062840" y="4467240"/>
            <a:ext cx="71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ZBA105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1943280" y="3521160"/>
            <a:ext cx="572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b) Haemocyte Susceptible-Resistant (Susceptible specific library)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2145240" y="179064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)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2145240" y="380520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)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4493880" y="17906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i)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4493880" y="378468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i)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2549520" y="2022480"/>
            <a:ext cx="200160" cy="181080"/>
          </a:xfrm>
          <a:prstGeom prst="hexagon">
            <a:avLst>
              <a:gd name="adj" fmla="val 27634"/>
              <a:gd name="vf" fmla="val 11547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2381400" y="2181240"/>
            <a:ext cx="199800" cy="181080"/>
          </a:xfrm>
          <a:prstGeom prst="hexagon">
            <a:avLst>
              <a:gd name="adj" fmla="val 27584"/>
              <a:gd name="vf" fmla="val 11547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4660920" y="2197080"/>
            <a:ext cx="200160" cy="181080"/>
          </a:xfrm>
          <a:prstGeom prst="hexagon">
            <a:avLst>
              <a:gd name="adj" fmla="val 27634"/>
              <a:gd name="vf" fmla="val 11547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4835520" y="2009880"/>
            <a:ext cx="200160" cy="180720"/>
          </a:xfrm>
          <a:prstGeom prst="hexagon">
            <a:avLst>
              <a:gd name="adj" fmla="val 27689"/>
              <a:gd name="vf" fmla="val 11547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6915240" y="2781360"/>
            <a:ext cx="199800" cy="181080"/>
          </a:xfrm>
          <a:prstGeom prst="hexagon">
            <a:avLst>
              <a:gd name="adj" fmla="val 27584"/>
              <a:gd name="vf" fmla="val 11547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6940440" y="2314440"/>
            <a:ext cx="150840" cy="1494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4206960" y="2300400"/>
            <a:ext cx="198360" cy="16164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5429160" y="2567160"/>
            <a:ext cx="198360" cy="16164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6489720" y="2297160"/>
            <a:ext cx="198360" cy="16200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6916680" y="2538360"/>
            <a:ext cx="198360" cy="16200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6956280" y="2101680"/>
            <a:ext cx="119160" cy="1191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800" bIns="37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6916680" y="3000240"/>
            <a:ext cx="200160" cy="173160"/>
          </a:xfrm>
          <a:prstGeom prst="diamond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960" bIns="3996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6988320" y="4156200"/>
            <a:ext cx="122040" cy="1238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1040" bIns="4104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6951600" y="4522680"/>
            <a:ext cx="195480" cy="138240"/>
          </a:xfrm>
          <a:prstGeom prst="triangle">
            <a:avLst>
              <a:gd name="adj" fmla="val 50000"/>
            </a:avLst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1-03-18T11:24:12Z</dcterms:created>
  <dc:creator>Aidan Emery</dc:creator>
  <dc:description/>
  <dc:language>en-US</dc:language>
  <cp:lastModifiedBy>annel</cp:lastModifiedBy>
  <cp:lastPrinted>2001-03-29T14:29:27Z</cp:lastPrinted>
  <dcterms:modified xsi:type="dcterms:W3CDTF">2006-09-26T14:39:30Z</dcterms:modified>
  <cp:revision>433</cp:revision>
  <dc:subject/>
  <dc:title>Gene Expression profiling in Biomphalaria glabrata strains which are susceptible or resistant to Schistosoma mansoni infection.</dc:title>
</cp:coreProperties>
</file>